
<file path=[Content_Types].xml><?xml version="1.0" encoding="utf-8"?>
<Types xmlns="http://schemas.openxmlformats.org/package/2006/content-types">
  <Default Extension="GIF" ContentType="image/gi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CC90709-98EB-4F43-9D17-23519CC240C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B586C07-9A1D-4DC6-A3CB-3B00EA6CBF0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8E7B36F-BAEC-4BFA-AEFB-E51FED7A11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3DF0E-A0B0-4EDD-B166-30ED7F9A89B6}" type="datetimeFigureOut">
              <a:rPr lang="zh-CN" altLang="en-US" smtClean="0"/>
              <a:t>2021/7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2F0E2A2-C7BC-439A-809F-774A7E9D64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AA6AFFD-B9FC-41BA-8638-1D03727EF4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B6998-3F03-4983-A7AB-0FB422DCEC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74561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C0B0D47-08BA-4BC3-8CA1-72AA3ADC43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5BBAF24-4274-4DDA-9EE6-379B2BB23C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7F8DBBA-D7E8-4B62-9BF4-623BC2DF18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3DF0E-A0B0-4EDD-B166-30ED7F9A89B6}" type="datetimeFigureOut">
              <a:rPr lang="zh-CN" altLang="en-US" smtClean="0"/>
              <a:t>2021/7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3561383-0249-4974-AC0F-3652E21075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290255D-B05B-4E36-B636-95D85B1DA8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B6998-3F03-4983-A7AB-0FB422DCEC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53867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8CF2B374-E409-4F67-B552-3EBDCA3476C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DD21313-E22E-4BB0-B8D7-97061B8521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701D7B0-5888-4C78-9D4B-521B193469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3DF0E-A0B0-4EDD-B166-30ED7F9A89B6}" type="datetimeFigureOut">
              <a:rPr lang="zh-CN" altLang="en-US" smtClean="0"/>
              <a:t>2021/7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BB34559-07C5-4D4D-9B6B-7606B47228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7E32C59-BCA1-4A9E-AB7C-85A9BFD473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B6998-3F03-4983-A7AB-0FB422DCEC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72073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A918F9F-567D-4273-8388-B17CF96EEA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3CD7FD1-0B91-4C19-9458-D2AC5E25075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C3730D9-3AB1-4217-952C-ACD2AF04CE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3DF0E-A0B0-4EDD-B166-30ED7F9A89B6}" type="datetimeFigureOut">
              <a:rPr lang="zh-CN" altLang="en-US" smtClean="0"/>
              <a:t>2021/7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C06B951-2DDC-45D7-A99A-17DB69C3B0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64FF02C-AEBF-47ED-8CC9-12B1204E11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B6998-3F03-4983-A7AB-0FB422DCEC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4815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BA5A4A4-1E1A-4A68-AE46-E3DF28D5F0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8D62B64-1737-42BF-8DE2-DBBE813847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EAD7D64-F82E-4225-AF08-A87E94BDF5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3DF0E-A0B0-4EDD-B166-30ED7F9A89B6}" type="datetimeFigureOut">
              <a:rPr lang="zh-CN" altLang="en-US" smtClean="0"/>
              <a:t>2021/7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F3E2695-2487-4283-B592-43A42F9C8B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FA0B149-EB74-472B-AFF5-8BBC583196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B6998-3F03-4983-A7AB-0FB422DCEC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2417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D53241D-DAB9-48B4-8858-F7CC6084B1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6522432-3505-415F-BC40-5628A1876E1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6C4E51C-B3B4-4ADF-B012-CB5B10A63F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0F6927A-6D1F-4D0B-A7D4-9C84E1FBDB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3DF0E-A0B0-4EDD-B166-30ED7F9A89B6}" type="datetimeFigureOut">
              <a:rPr lang="zh-CN" altLang="en-US" smtClean="0"/>
              <a:t>2021/7/2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EA47AA6-38A0-4F5D-93C8-D514C3E01E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6E1D3F6-A38C-4419-A835-0312C55914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B6998-3F03-4983-A7AB-0FB422DCEC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39800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2BDBB26-0CCF-4B50-88F0-F805A1E85B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ED94CB9-F1F2-4C78-A717-1E43AC5233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CE1D3B2-C17D-4A66-9C10-FCEC7F8A72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ABB1FBE-A84C-4080-9471-54153C850A8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74A044E-89BC-47EE-AF0A-1234997F731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F5C0F2E-30F8-4893-8F49-A4ED6D6FAF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3DF0E-A0B0-4EDD-B166-30ED7F9A89B6}" type="datetimeFigureOut">
              <a:rPr lang="zh-CN" altLang="en-US" smtClean="0"/>
              <a:t>2021/7/2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897963E-B78B-4EF6-BB6F-FD0AB452FE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B652DE9-2F0B-46E5-815D-6365B86A00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B6998-3F03-4983-A7AB-0FB422DCEC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35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5E400AF-4D66-4D78-AB4E-A10BD208E5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F14FF5E-1DA2-4386-AE57-B62134726C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3DF0E-A0B0-4EDD-B166-30ED7F9A89B6}" type="datetimeFigureOut">
              <a:rPr lang="zh-CN" altLang="en-US" smtClean="0"/>
              <a:t>2021/7/2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43FF9B3-3E19-464B-8F41-7E88A8EA13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FA3565A-1171-4CBB-98B4-330CE4F990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B6998-3F03-4983-A7AB-0FB422DCEC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1191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4F344AA-1213-4641-98DA-27305ABFE2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3DF0E-A0B0-4EDD-B166-30ED7F9A89B6}" type="datetimeFigureOut">
              <a:rPr lang="zh-CN" altLang="en-US" smtClean="0"/>
              <a:t>2021/7/2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A38D459-C72F-4A4C-A04A-F0290E0B99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8985804-039F-4D01-8DF0-F0DCE155E6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B6998-3F03-4983-A7AB-0FB422DCEC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43818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7B879CD-CB32-432D-A828-F1E3DAB45C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7210947-AF84-44C4-8609-F2209D7BFED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B16FE53-BD7D-4814-9205-B9F2FB4D96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7D3796C-68B0-492B-976E-387281D57D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3DF0E-A0B0-4EDD-B166-30ED7F9A89B6}" type="datetimeFigureOut">
              <a:rPr lang="zh-CN" altLang="en-US" smtClean="0"/>
              <a:t>2021/7/2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2D4A15C-DB4F-4FC7-AD64-9B9E97987A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B6C5645-699C-456E-B846-A9FEFED52C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B6998-3F03-4983-A7AB-0FB422DCEC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01940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61BFBEE-BEFC-40DE-BC2C-0D6D3CF819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727C35A-A30B-4380-829B-D81192FF968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D7036EC-692A-4029-9766-A31A9EE681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1E32945-67DA-4A7A-9BB6-B371021B7C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3DF0E-A0B0-4EDD-B166-30ED7F9A89B6}" type="datetimeFigureOut">
              <a:rPr lang="zh-CN" altLang="en-US" smtClean="0"/>
              <a:t>2021/7/2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7A8C9F6-7673-416C-9B60-7FC78FD964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D3116CD-963C-4E5C-A300-BDB1257292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B6998-3F03-4983-A7AB-0FB422DCEC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55153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37AB7D3-5AC3-4AC1-9556-6C7254C207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FF21275-22B0-4597-BF4E-D8C61535F8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D841DCE-E09F-416C-A08E-3BB5BC27BAF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33DF0E-A0B0-4EDD-B166-30ED7F9A89B6}" type="datetimeFigureOut">
              <a:rPr lang="zh-CN" altLang="en-US" smtClean="0"/>
              <a:t>2021/7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B7B3517-DA98-4662-AD27-E15216840FF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4CBB4CC-B225-41B2-9241-C5ED648D623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7B6998-3F03-4983-A7AB-0FB422DCEC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76076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649605"/>
          </a:xfrm>
        </p:spPr>
        <p:txBody>
          <a:bodyPr>
            <a:normAutofit/>
          </a:bodyPr>
          <a:lstStyle/>
          <a:p>
            <a:r>
              <a:rPr lang="zh-CN" altLang="en-US" sz="2800" dirty="0">
                <a:latin typeface="微软雅黑" panose="020B0503020204020204" pitchFamily="34" charset="-122"/>
                <a:ea typeface="微软雅黑" panose="020B0503020204020204" pitchFamily="34" charset="-122"/>
              </a:rPr>
              <a:t>Simulation of self-driven collective dynamics</a:t>
            </a:r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396776" y="1236980"/>
            <a:ext cx="3856830" cy="3856830"/>
          </a:xfr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7585" y="1236980"/>
            <a:ext cx="3856830" cy="385683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62080" y="1238250"/>
            <a:ext cx="3856830" cy="3856830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752475" y="4972704"/>
            <a:ext cx="10677525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Supplementary figure 1. </a:t>
            </a:r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Simulated motion of particles. (a) When low density and low noise(N=300,L=25,η=0.1)</a:t>
            </a:r>
            <a:r>
              <a:rPr lang="zh-CN" altLang="en-US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, </a:t>
            </a:r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small clusters moving in random directions are formed in the collective.(b)</a:t>
            </a:r>
            <a:r>
              <a:rPr lang="zh-CN" altLang="en-US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In the case of h</a:t>
            </a:r>
            <a:r>
              <a:rPr lang="zh-CN" altLang="en-US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igh density and high noise</a:t>
            </a:r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(</a:t>
            </a:r>
            <a:r>
              <a:rPr lang="pt-BR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N=300,L=7</a:t>
            </a:r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,</a:t>
            </a:r>
            <a:r>
              <a:rPr lang="pt-BR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η=2.0</a:t>
            </a:r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)</a:t>
            </a:r>
            <a:r>
              <a:rPr lang="zh-CN" altLang="en-US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,  random motions with a certain correlation appear among the particles</a:t>
            </a:r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.(c)</a:t>
            </a:r>
            <a:r>
              <a:rPr lang="zh-CN" altLang="en-US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When h</a:t>
            </a:r>
            <a:r>
              <a:rPr lang="zh-CN" altLang="en-US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igh density and low noise</a:t>
            </a:r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(N=300,L=5,η=0.1)</a:t>
            </a:r>
            <a:r>
              <a:rPr lang="zh-CN" altLang="en-US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, the system will be synchronized in a short time</a:t>
            </a:r>
            <a:r>
              <a:rPr lang="en-US" altLang="zh-CN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.</a:t>
            </a:r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  <a:p>
            <a:endParaRPr lang="en-US" altLang="zh-CN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  <a:p>
            <a:pPr algn="l"/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838200" y="1167130"/>
            <a:ext cx="7009901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S</a:t>
            </a:r>
            <a:r>
              <a:rPr lang="zh-CN" altLang="en-US" dirty="0">
                <a:latin typeface="微软雅黑" panose="020B0503020204020204" pitchFamily="34" charset="-122"/>
                <a:ea typeface="微软雅黑" panose="020B0503020204020204" pitchFamily="34" charset="-122"/>
              </a:rPr>
              <a:t>ystem changes over time under </a:t>
            </a:r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various</a:t>
            </a:r>
            <a:r>
              <a:rPr lang="zh-CN" altLang="en-US" dirty="0">
                <a:latin typeface="微软雅黑" panose="020B0503020204020204" pitchFamily="34" charset="-122"/>
                <a:ea typeface="微软雅黑" panose="020B0503020204020204" pitchFamily="34" charset="-122"/>
              </a:rPr>
              <a:t> densities and noises</a:t>
            </a:r>
            <a:r>
              <a:rPr lang="en-US" altLang="zh-CN" dirty="0">
                <a:latin typeface="微软雅黑" panose="020B0503020204020204" pitchFamily="34" charset="-122"/>
                <a:ea typeface="微软雅黑" panose="020B0503020204020204" pitchFamily="34" charset="-122"/>
              </a:rPr>
              <a:t>.</a:t>
            </a: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3BCFB33D-AD7B-4975-8049-765A924AEAAC}"/>
              </a:ext>
            </a:extLst>
          </p:cNvPr>
          <p:cNvSpPr txBox="1"/>
          <p:nvPr/>
        </p:nvSpPr>
        <p:spPr>
          <a:xfrm>
            <a:off x="953810" y="1758712"/>
            <a:ext cx="497252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Helvetica" panose="020B0604020202020204" pitchFamily="34" charset="0"/>
                <a:cs typeface="Helvetica" panose="020B0604020202020204" pitchFamily="34" charset="0"/>
              </a:rPr>
              <a:t>(a)</a:t>
            </a:r>
            <a:endParaRPr lang="zh-CN" altLang="en-US" sz="2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CE6D792A-5B8F-4CF9-BCC4-606727971AAA}"/>
              </a:ext>
            </a:extLst>
          </p:cNvPr>
          <p:cNvSpPr txBox="1"/>
          <p:nvPr/>
        </p:nvSpPr>
        <p:spPr>
          <a:xfrm>
            <a:off x="4710910" y="1766371"/>
            <a:ext cx="497252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Helvetica" panose="020B0604020202020204" pitchFamily="34" charset="0"/>
                <a:cs typeface="Helvetica" panose="020B0604020202020204" pitchFamily="34" charset="0"/>
              </a:rPr>
              <a:t>(b)</a:t>
            </a:r>
            <a:endParaRPr lang="zh-CN" altLang="en-US" sz="2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6DCB29D2-EC7A-4326-9EBA-F3FFF03D4C4B}"/>
              </a:ext>
            </a:extLst>
          </p:cNvPr>
          <p:cNvSpPr txBox="1"/>
          <p:nvPr/>
        </p:nvSpPr>
        <p:spPr>
          <a:xfrm>
            <a:off x="8259332" y="1758712"/>
            <a:ext cx="482824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latin typeface="Helvetica" panose="020B0604020202020204" pitchFamily="34" charset="0"/>
                <a:cs typeface="Helvetica" panose="020B0604020202020204" pitchFamily="34" charset="0"/>
              </a:rPr>
              <a:t>(c)</a:t>
            </a:r>
            <a:endParaRPr lang="zh-CN" altLang="en-US" sz="2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73474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141</Words>
  <Application>Microsoft Office PowerPoint</Application>
  <PresentationFormat>宽屏</PresentationFormat>
  <Paragraphs>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微软雅黑</vt:lpstr>
      <vt:lpstr>Arial</vt:lpstr>
      <vt:lpstr>Helvetica</vt:lpstr>
      <vt:lpstr>Times New Roman</vt:lpstr>
      <vt:lpstr>Office 主题​​</vt:lpstr>
      <vt:lpstr>Simulation of self-driven collective dynamic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imulation of self-driven collective dynamics</dc:title>
  <dc:creator>WANG RUI</dc:creator>
  <cp:lastModifiedBy>RUI WANG</cp:lastModifiedBy>
  <cp:revision>8</cp:revision>
  <dcterms:created xsi:type="dcterms:W3CDTF">2021-01-30T09:27:49Z</dcterms:created>
  <dcterms:modified xsi:type="dcterms:W3CDTF">2021-07-26T13:50:33Z</dcterms:modified>
</cp:coreProperties>
</file>